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6116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C4F252-5487-42E1-926A-FB118482F3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5ADE6-E38B-4F0D-86A5-ABC3B6469B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6A0C4-E2FE-4791-B635-74C1089D7E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6BA5EC-959B-4EEA-9A04-1D6F9E7B81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31405-01D9-4C68-876B-11963A4931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AA0D5-DD32-4E20-8025-A8A9C4D8D8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65D75-30CA-4CC4-8D90-11F42DF23D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67AF1-A87F-4768-AF50-E15D571D7F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4ACBB-6D69-4258-A9C0-D803996EE7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AAE0F-787A-4993-9895-D10A0C7947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E76BD-DBEA-40A1-9214-1ADD3F50E1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B601A-C55C-43E9-8C9E-4BA991037F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3CA0C0-40AD-4869-8BDA-6F04F7191BF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432000" y="1767960"/>
            <a:ext cx="1081080" cy="23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Lesion area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103480" y="1192320"/>
            <a:ext cx="1706400" cy="152640"/>
            <a:chOff x="2103480" y="1192320"/>
            <a:chExt cx="1706400" cy="152640"/>
          </a:xfrm>
        </p:grpSpPr>
        <p:sp>
          <p:nvSpPr>
            <p:cNvPr id="43" name=""/>
            <p:cNvSpPr/>
            <p:nvPr/>
          </p:nvSpPr>
          <p:spPr>
            <a:xfrm>
              <a:off x="2103480" y="1240200"/>
              <a:ext cx="74520" cy="6192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5120" bIns="15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209680" y="1192320"/>
              <a:ext cx="160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Wild type (Minghui 6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"/>
          <p:cNvSpPr/>
          <p:nvPr/>
        </p:nvSpPr>
        <p:spPr>
          <a:xfrm rot="16200000">
            <a:off x="369000" y="3048480"/>
            <a:ext cx="1081080" cy="35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Rel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52480" y="4343400"/>
            <a:ext cx="5472000" cy="157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Additional file 6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The increased susceptibility cosegregated with suppressed expression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sWRKY1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in two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sWRKY1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-suppressed T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families. Disease was scored at 14 d after infection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Xoo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strain PXO61. RNA samples were obtained after disease scoring. The expression level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sWRKY1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in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sWRKY1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-suppressed plants was calculated relative to that in wild-type (WT) Minghui 63. Bars represent mean (three leaves for lesion area and three replicates for expression level)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standard deviation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. Asterisk indicates a significant difference (</a:t>
            </a:r>
            <a:r>
              <a:rPr b="0" i="1" lang="zh-CN" sz="12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 &lt; 0.05) from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wild-type 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Minghui 63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"/>
          <p:cNvGrpSpPr/>
          <p:nvPr/>
        </p:nvGrpSpPr>
        <p:grpSpPr>
          <a:xfrm>
            <a:off x="1227960" y="3801960"/>
            <a:ext cx="2089800" cy="122040"/>
            <a:chOff x="1227960" y="3801960"/>
            <a:chExt cx="2089800" cy="122040"/>
          </a:xfrm>
        </p:grpSpPr>
        <p:sp>
          <p:nvSpPr>
            <p:cNvPr id="48" name=""/>
            <p:cNvSpPr/>
            <p:nvPr/>
          </p:nvSpPr>
          <p:spPr>
            <a:xfrm>
              <a:off x="1227960" y="3801960"/>
              <a:ext cx="159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48356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67256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87092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07432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26476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7248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65680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87424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063240" y="380196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213360" y="380196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1087560" y="1314360"/>
            <a:ext cx="104400" cy="1204560"/>
            <a:chOff x="1087560" y="1314360"/>
            <a:chExt cx="104400" cy="1204560"/>
          </a:xfrm>
        </p:grpSpPr>
        <p:sp>
          <p:nvSpPr>
            <p:cNvPr id="60" name=""/>
            <p:cNvSpPr/>
            <p:nvPr/>
          </p:nvSpPr>
          <p:spPr>
            <a:xfrm>
              <a:off x="1139040" y="239688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139040" y="21794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087560" y="196200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087560" y="174924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087560" y="153180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087560" y="131436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3629160" y="1271520"/>
            <a:ext cx="2371680" cy="138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"/>
          <p:cNvGrpSpPr/>
          <p:nvPr/>
        </p:nvGrpSpPr>
        <p:grpSpPr>
          <a:xfrm>
            <a:off x="3640320" y="1343160"/>
            <a:ext cx="104400" cy="1197000"/>
            <a:chOff x="3640320" y="1343160"/>
            <a:chExt cx="104400" cy="1197000"/>
          </a:xfrm>
        </p:grpSpPr>
        <p:sp>
          <p:nvSpPr>
            <p:cNvPr id="68" name=""/>
            <p:cNvSpPr/>
            <p:nvPr/>
          </p:nvSpPr>
          <p:spPr>
            <a:xfrm>
              <a:off x="3691800" y="24181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691800" y="21499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640320" y="188316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640320" y="161172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640320" y="1343160"/>
              <a:ext cx="104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"/>
          <p:cNvGrpSpPr/>
          <p:nvPr/>
        </p:nvGrpSpPr>
        <p:grpSpPr>
          <a:xfrm>
            <a:off x="3802680" y="3800520"/>
            <a:ext cx="2065320" cy="122040"/>
            <a:chOff x="3802680" y="3800520"/>
            <a:chExt cx="2065320" cy="122040"/>
          </a:xfrm>
        </p:grpSpPr>
        <p:sp>
          <p:nvSpPr>
            <p:cNvPr id="74" name=""/>
            <p:cNvSpPr/>
            <p:nvPr/>
          </p:nvSpPr>
          <p:spPr>
            <a:xfrm>
              <a:off x="3802680" y="3800520"/>
              <a:ext cx="159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07088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27392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49316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71996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92948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14692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35968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58684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815440" y="38005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1062000" y="2625840"/>
            <a:ext cx="2325600" cy="1217160"/>
            <a:chOff x="1062000" y="2625840"/>
            <a:chExt cx="2325600" cy="1217160"/>
          </a:xfrm>
        </p:grpSpPr>
        <p:sp>
          <p:nvSpPr>
            <p:cNvPr id="85" name=""/>
            <p:cNvSpPr/>
            <p:nvPr/>
          </p:nvSpPr>
          <p:spPr>
            <a:xfrm>
              <a:off x="1219320" y="2666880"/>
              <a:ext cx="2168280" cy="1113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219320" y="2666880"/>
              <a:ext cx="2168280" cy="111312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274760" y="3220920"/>
              <a:ext cx="82440" cy="559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274760" y="3220920"/>
              <a:ext cx="82440" cy="55908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473120" y="3030480"/>
              <a:ext cx="79560" cy="7495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666800" y="3508200"/>
              <a:ext cx="84240" cy="27180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865160" y="3135240"/>
              <a:ext cx="84240" cy="6447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063880" y="3473280"/>
              <a:ext cx="79200" cy="3067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259000" y="3598920"/>
              <a:ext cx="84240" cy="1810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457360" y="3552840"/>
              <a:ext cx="79560" cy="2271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652840" y="3629160"/>
              <a:ext cx="82440" cy="15084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851200" y="3608280"/>
              <a:ext cx="82440" cy="1717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049560" y="3684600"/>
              <a:ext cx="79560" cy="9540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243240" y="3659040"/>
              <a:ext cx="84240" cy="1209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1314360" y="3156120"/>
              <a:ext cx="0" cy="64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301760" y="3156120"/>
              <a:ext cx="284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1512720" y="2975040"/>
              <a:ext cx="0" cy="55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500120" y="2975040"/>
              <a:ext cx="288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1706400" y="3472920"/>
              <a:ext cx="0" cy="34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695600" y="347328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1905120" y="3065400"/>
              <a:ext cx="0" cy="698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893960" y="306540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2103480" y="3396960"/>
              <a:ext cx="0" cy="759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092320" y="339732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2298600" y="3593880"/>
              <a:ext cx="0" cy="46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287440" y="359424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2496960" y="3533400"/>
              <a:ext cx="0" cy="19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486160" y="353376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2692440" y="3568680"/>
              <a:ext cx="0" cy="604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679840" y="3568680"/>
              <a:ext cx="284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2890800" y="3603240"/>
              <a:ext cx="0" cy="46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878200" y="3603600"/>
              <a:ext cx="284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V="1">
              <a:off x="3089160" y="3673080"/>
              <a:ext cx="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076560" y="3673440"/>
              <a:ext cx="2844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3282840" y="3643200"/>
              <a:ext cx="0" cy="158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271680" y="3643200"/>
              <a:ext cx="2700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219320" y="2666880"/>
              <a:ext cx="0" cy="111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219320" y="378000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219320" y="350352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219320" y="322596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219320" y="294480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219320" y="2666880"/>
              <a:ext cx="19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219320" y="3780000"/>
              <a:ext cx="2168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flipV="1">
              <a:off x="121932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141768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flipV="1">
              <a:off x="161136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180972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200808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220356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flipV="1">
              <a:off x="240192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259704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279576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299412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flipV="1">
              <a:off x="318780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3387600" y="3754080"/>
              <a:ext cx="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0" name=""/>
            <p:cNvGrpSpPr/>
            <p:nvPr/>
          </p:nvGrpSpPr>
          <p:grpSpPr>
            <a:xfrm>
              <a:off x="1062000" y="2625840"/>
              <a:ext cx="130320" cy="1217160"/>
              <a:chOff x="1062000" y="2625840"/>
              <a:chExt cx="130320" cy="1217160"/>
            </a:xfrm>
          </p:grpSpPr>
          <p:sp>
            <p:nvSpPr>
              <p:cNvPr id="141" name=""/>
              <p:cNvSpPr/>
              <p:nvPr/>
            </p:nvSpPr>
            <p:spPr>
              <a:xfrm>
                <a:off x="1062000" y="372096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062000" y="344664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062000" y="317484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062000" y="290052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062000" y="262584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2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6" name=""/>
          <p:cNvGrpSpPr/>
          <p:nvPr/>
        </p:nvGrpSpPr>
        <p:grpSpPr>
          <a:xfrm>
            <a:off x="3600360" y="1181160"/>
            <a:ext cx="1981080" cy="152640"/>
            <a:chOff x="3600360" y="1181160"/>
            <a:chExt cx="1981080" cy="152640"/>
          </a:xfrm>
        </p:grpSpPr>
        <p:sp>
          <p:nvSpPr>
            <p:cNvPr id="147" name=""/>
            <p:cNvSpPr/>
            <p:nvPr/>
          </p:nvSpPr>
          <p:spPr>
            <a:xfrm>
              <a:off x="3724200" y="1181160"/>
              <a:ext cx="1857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</a:rPr>
                <a:t>OsWRKY13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-suppressed pla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600360" y="1233720"/>
              <a:ext cx="74520" cy="619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5120" bIns="15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9" name=""/>
          <p:cNvSpPr/>
          <p:nvPr/>
        </p:nvSpPr>
        <p:spPr>
          <a:xfrm>
            <a:off x="1808640" y="3924360"/>
            <a:ext cx="115920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RKY13S2 T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famil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467000" y="3924360"/>
            <a:ext cx="18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1" name=""/>
          <p:cNvGrpSpPr/>
          <p:nvPr/>
        </p:nvGrpSpPr>
        <p:grpSpPr>
          <a:xfrm>
            <a:off x="1171440" y="1324080"/>
            <a:ext cx="2209680" cy="1130040"/>
            <a:chOff x="1171440" y="1324080"/>
            <a:chExt cx="2209680" cy="1130040"/>
          </a:xfrm>
        </p:grpSpPr>
        <p:grpSp>
          <p:nvGrpSpPr>
            <p:cNvPr id="152" name=""/>
            <p:cNvGrpSpPr/>
            <p:nvPr/>
          </p:nvGrpSpPr>
          <p:grpSpPr>
            <a:xfrm>
              <a:off x="1219320" y="1371600"/>
              <a:ext cx="2161800" cy="1082520"/>
              <a:chOff x="1219320" y="1371600"/>
              <a:chExt cx="2161800" cy="1082520"/>
            </a:xfrm>
          </p:grpSpPr>
          <p:sp>
            <p:nvSpPr>
              <p:cNvPr id="153" name=""/>
              <p:cNvSpPr/>
              <p:nvPr/>
            </p:nvSpPr>
            <p:spPr>
              <a:xfrm>
                <a:off x="1219320" y="1371600"/>
                <a:ext cx="2161800" cy="1082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1219320" y="1371600"/>
                <a:ext cx="2161800" cy="1082520"/>
              </a:xfrm>
              <a:prstGeom prst="rect">
                <a:avLst/>
              </a:prstGeom>
              <a:noFill/>
              <a:ln w="46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1276560" y="2003040"/>
                <a:ext cx="82800" cy="450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1276560" y="2003040"/>
                <a:ext cx="82800" cy="450720"/>
              </a:xfrm>
              <a:prstGeom prst="rect">
                <a:avLst/>
              </a:prstGeom>
              <a:blipFill rotWithShape="0">
                <a:blip r:embed="rId3"/>
                <a:srcRect/>
                <a:tile tx="0" ty="0" sx="100000" sy="100000" algn="ctr"/>
              </a:blip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1474920" y="2023920"/>
                <a:ext cx="78120" cy="42984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1667880" y="1842840"/>
                <a:ext cx="83160" cy="61092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1865880" y="1987200"/>
                <a:ext cx="82800" cy="46656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2062440" y="1933200"/>
                <a:ext cx="84240" cy="52056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2260080" y="1858680"/>
                <a:ext cx="79920" cy="59508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2453400" y="2012760"/>
                <a:ext cx="84600" cy="44100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651760" y="1806480"/>
                <a:ext cx="84240" cy="64728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849760" y="1858680"/>
                <a:ext cx="82800" cy="59508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047400" y="1625400"/>
                <a:ext cx="79920" cy="82836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240720" y="1609560"/>
                <a:ext cx="82800" cy="84420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 flipV="1">
                <a:off x="1315080" y="1885320"/>
                <a:ext cx="0" cy="11700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302480" y="1885680"/>
                <a:ext cx="2988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 flipV="1">
                <a:off x="1513080" y="1917000"/>
                <a:ext cx="0" cy="10620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1500120" y="191736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 flipV="1">
                <a:off x="1706040" y="1785600"/>
                <a:ext cx="0" cy="5688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693440" y="178560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 flipV="1">
                <a:off x="1904400" y="1939320"/>
                <a:ext cx="0" cy="4716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1891440" y="193968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 flipV="1">
                <a:off x="2102400" y="1881000"/>
                <a:ext cx="0" cy="5184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2089800" y="1881000"/>
                <a:ext cx="2988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 flipV="1">
                <a:off x="2300400" y="1731600"/>
                <a:ext cx="0" cy="126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2287440" y="173160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 flipV="1">
                <a:off x="2493360" y="1971360"/>
                <a:ext cx="0" cy="4104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2480760" y="197136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 flipV="1">
                <a:off x="2691360" y="1704600"/>
                <a:ext cx="0" cy="1015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2678760" y="170460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 flipV="1">
                <a:off x="2889720" y="1806480"/>
                <a:ext cx="0" cy="5184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2876760" y="1806480"/>
                <a:ext cx="2988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 flipV="1">
                <a:off x="3087720" y="1445760"/>
                <a:ext cx="0" cy="1789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3073320" y="1446120"/>
                <a:ext cx="3168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 flipV="1">
                <a:off x="3280680" y="1455120"/>
                <a:ext cx="0" cy="153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3268080" y="1455480"/>
                <a:ext cx="30240" cy="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1219320" y="1371600"/>
                <a:ext cx="0" cy="1082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219320" y="2454120"/>
                <a:ext cx="17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219320" y="2236680"/>
                <a:ext cx="17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219320" y="2019240"/>
                <a:ext cx="17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1219320" y="1806480"/>
                <a:ext cx="17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219320" y="1589040"/>
                <a:ext cx="17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219320" y="1371600"/>
                <a:ext cx="17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219320" y="2454120"/>
                <a:ext cx="21618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flipV="1">
                <a:off x="121932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V="1">
                <a:off x="141732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 flipV="1">
                <a:off x="161064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flipV="1">
                <a:off x="180828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 flipV="1">
                <a:off x="200628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V="1">
                <a:off x="220284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 flipV="1">
                <a:off x="239796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V="1">
                <a:off x="259416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 flipV="1">
                <a:off x="279216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V="1">
                <a:off x="299016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 flipV="1">
                <a:off x="318312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V="1">
                <a:off x="3381120" y="2431440"/>
                <a:ext cx="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9" name=""/>
            <p:cNvSpPr/>
            <p:nvPr/>
          </p:nvSpPr>
          <p:spPr>
            <a:xfrm>
              <a:off x="1171440" y="1324080"/>
              <a:ext cx="144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PXO61 infec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"/>
          <p:cNvGrpSpPr/>
          <p:nvPr/>
        </p:nvGrpSpPr>
        <p:grpSpPr>
          <a:xfrm>
            <a:off x="3728880" y="1333440"/>
            <a:ext cx="2220840" cy="1120680"/>
            <a:chOff x="3728880" y="1333440"/>
            <a:chExt cx="2220840" cy="1120680"/>
          </a:xfrm>
        </p:grpSpPr>
        <p:sp>
          <p:nvSpPr>
            <p:cNvPr id="211" name=""/>
            <p:cNvSpPr/>
            <p:nvPr/>
          </p:nvSpPr>
          <p:spPr>
            <a:xfrm>
              <a:off x="3767040" y="1380960"/>
              <a:ext cx="2182680" cy="1073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767040" y="1380960"/>
              <a:ext cx="2182680" cy="1073160"/>
            </a:xfrm>
            <a:prstGeom prst="rect">
              <a:avLst/>
            </a:prstGeom>
            <a:noFill/>
            <a:ln w="32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3831120" y="1895400"/>
              <a:ext cx="85680" cy="558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831120" y="1895400"/>
              <a:ext cx="85680" cy="55872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047480" y="1749240"/>
              <a:ext cx="90720" cy="70488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267440" y="1753920"/>
              <a:ext cx="87120" cy="7002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484160" y="1730160"/>
              <a:ext cx="90360" cy="7239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705560" y="1763640"/>
              <a:ext cx="85680" cy="69048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921920" y="1685520"/>
              <a:ext cx="85680" cy="7686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138640" y="1827000"/>
              <a:ext cx="90360" cy="6271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358960" y="1930320"/>
              <a:ext cx="85680" cy="5238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575320" y="1685520"/>
              <a:ext cx="90720" cy="7686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796720" y="1680840"/>
              <a:ext cx="85680" cy="77328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3873960" y="1749240"/>
              <a:ext cx="0" cy="146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3862800" y="1749240"/>
              <a:ext cx="27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4090320" y="1696680"/>
              <a:ext cx="0" cy="52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079160" y="1696680"/>
              <a:ext cx="27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4310280" y="1725120"/>
              <a:ext cx="0" cy="28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299120" y="1725480"/>
              <a:ext cx="27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V="1">
              <a:off x="4527000" y="1628640"/>
              <a:ext cx="0" cy="101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515840" y="1628640"/>
              <a:ext cx="27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4748760" y="1671480"/>
              <a:ext cx="0" cy="92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735440" y="1671480"/>
              <a:ext cx="28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4965120" y="1598400"/>
              <a:ext cx="0" cy="871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952520" y="1598400"/>
              <a:ext cx="28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5181840" y="1793160"/>
              <a:ext cx="0" cy="33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5169240" y="1793520"/>
              <a:ext cx="28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flipV="1">
              <a:off x="5401800" y="1904400"/>
              <a:ext cx="0" cy="25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390640" y="1904760"/>
              <a:ext cx="27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5618160" y="1607760"/>
              <a:ext cx="0" cy="77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5607000" y="1607760"/>
              <a:ext cx="27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5839560" y="165708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5826960" y="1657080"/>
              <a:ext cx="28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3767040" y="1380960"/>
              <a:ext cx="0" cy="1073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3767040" y="245412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767040" y="218736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3767040" y="191916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767040" y="164772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767040" y="1380960"/>
              <a:ext cx="2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3767040" y="2454120"/>
              <a:ext cx="2182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flipV="1">
              <a:off x="376704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flipV="1">
              <a:off x="398376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flipV="1">
              <a:off x="420516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442188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flipV="1">
              <a:off x="464184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485856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flipV="1">
              <a:off x="507528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flipV="1">
              <a:off x="529668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flipV="1">
              <a:off x="551304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573300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flipV="1">
              <a:off x="5949720" y="243036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3728880" y="1333440"/>
              <a:ext cx="144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PXO61 infec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3" name=""/>
          <p:cNvSpPr/>
          <p:nvPr/>
        </p:nvSpPr>
        <p:spPr>
          <a:xfrm>
            <a:off x="4076640" y="3924360"/>
            <a:ext cx="180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4370760" y="3924360"/>
            <a:ext cx="115920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RKY13S5 T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famil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1171440" y="262908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OsWRKY1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6" name=""/>
          <p:cNvGrpSpPr/>
          <p:nvPr/>
        </p:nvGrpSpPr>
        <p:grpSpPr>
          <a:xfrm>
            <a:off x="3616560" y="2629080"/>
            <a:ext cx="2327040" cy="1217160"/>
            <a:chOff x="3616560" y="2629080"/>
            <a:chExt cx="2327040" cy="1217160"/>
          </a:xfrm>
        </p:grpSpPr>
        <p:grpSp>
          <p:nvGrpSpPr>
            <p:cNvPr id="267" name=""/>
            <p:cNvGrpSpPr/>
            <p:nvPr/>
          </p:nvGrpSpPr>
          <p:grpSpPr>
            <a:xfrm>
              <a:off x="3616560" y="2629080"/>
              <a:ext cx="130320" cy="1217160"/>
              <a:chOff x="3616560" y="2629080"/>
              <a:chExt cx="130320" cy="1217160"/>
            </a:xfrm>
          </p:grpSpPr>
          <p:sp>
            <p:nvSpPr>
              <p:cNvPr id="268" name=""/>
              <p:cNvSpPr/>
              <p:nvPr/>
            </p:nvSpPr>
            <p:spPr>
              <a:xfrm>
                <a:off x="3616560" y="372420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3616560" y="344988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3616560" y="317808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3616560" y="290376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3616560" y="262908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2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3" name=""/>
            <p:cNvGrpSpPr/>
            <p:nvPr/>
          </p:nvGrpSpPr>
          <p:grpSpPr>
            <a:xfrm>
              <a:off x="3713400" y="2629080"/>
              <a:ext cx="2230200" cy="1145880"/>
              <a:chOff x="3713400" y="2629080"/>
              <a:chExt cx="2230200" cy="1145880"/>
            </a:xfrm>
          </p:grpSpPr>
          <p:grpSp>
            <p:nvGrpSpPr>
              <p:cNvPr id="274" name=""/>
              <p:cNvGrpSpPr/>
              <p:nvPr/>
            </p:nvGrpSpPr>
            <p:grpSpPr>
              <a:xfrm>
                <a:off x="3770280" y="2666880"/>
                <a:ext cx="2173320" cy="1108080"/>
                <a:chOff x="3770280" y="2666880"/>
                <a:chExt cx="2173320" cy="1108080"/>
              </a:xfrm>
            </p:grpSpPr>
            <p:sp>
              <p:nvSpPr>
                <p:cNvPr id="275" name=""/>
                <p:cNvSpPr/>
                <p:nvPr/>
              </p:nvSpPr>
              <p:spPr>
                <a:xfrm>
                  <a:off x="3770280" y="2666880"/>
                  <a:ext cx="2173320" cy="1108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"/>
                <p:cNvSpPr/>
                <p:nvPr/>
              </p:nvSpPr>
              <p:spPr>
                <a:xfrm>
                  <a:off x="3770280" y="2666880"/>
                  <a:ext cx="2173320" cy="1108080"/>
                </a:xfrm>
                <a:prstGeom prst="rect">
                  <a:avLst/>
                </a:prstGeom>
                <a:noFill/>
                <a:ln w="468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"/>
                <p:cNvSpPr/>
                <p:nvPr/>
              </p:nvSpPr>
              <p:spPr>
                <a:xfrm>
                  <a:off x="3834720" y="3202920"/>
                  <a:ext cx="88200" cy="5716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"/>
                <p:cNvSpPr/>
                <p:nvPr/>
              </p:nvSpPr>
              <p:spPr>
                <a:xfrm>
                  <a:off x="3834720" y="3202920"/>
                  <a:ext cx="88200" cy="571680"/>
                </a:xfrm>
                <a:prstGeom prst="rect">
                  <a:avLst/>
                </a:prstGeom>
                <a:blipFill rotWithShape="0">
                  <a:blip r:embed="rId5"/>
                  <a:srcRect/>
                  <a:tile tx="0" ty="0" sx="100000" sy="100000" algn="ctr"/>
                </a:blip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"/>
                <p:cNvSpPr/>
                <p:nvPr/>
              </p:nvSpPr>
              <p:spPr>
                <a:xfrm>
                  <a:off x="4050720" y="3431880"/>
                  <a:ext cx="88200" cy="34272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"/>
                <p:cNvSpPr/>
                <p:nvPr/>
              </p:nvSpPr>
              <p:spPr>
                <a:xfrm>
                  <a:off x="4266360" y="3370680"/>
                  <a:ext cx="93240" cy="40392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"/>
                <p:cNvSpPr/>
                <p:nvPr/>
              </p:nvSpPr>
              <p:spPr>
                <a:xfrm>
                  <a:off x="4487400" y="3299760"/>
                  <a:ext cx="88200" cy="47484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"/>
                <p:cNvSpPr/>
                <p:nvPr/>
              </p:nvSpPr>
              <p:spPr>
                <a:xfrm>
                  <a:off x="4704840" y="3437640"/>
                  <a:ext cx="88200" cy="33696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"/>
                <p:cNvSpPr/>
                <p:nvPr/>
              </p:nvSpPr>
              <p:spPr>
                <a:xfrm>
                  <a:off x="4920840" y="3544560"/>
                  <a:ext cx="87840" cy="23004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"/>
                <p:cNvSpPr/>
                <p:nvPr/>
              </p:nvSpPr>
              <p:spPr>
                <a:xfrm>
                  <a:off x="5136840" y="3227760"/>
                  <a:ext cx="88200" cy="54684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"/>
                <p:cNvSpPr/>
                <p:nvPr/>
              </p:nvSpPr>
              <p:spPr>
                <a:xfrm>
                  <a:off x="5353920" y="2738880"/>
                  <a:ext cx="91440" cy="103572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"/>
                <p:cNvSpPr/>
                <p:nvPr/>
              </p:nvSpPr>
              <p:spPr>
                <a:xfrm>
                  <a:off x="5574960" y="3519360"/>
                  <a:ext cx="87840" cy="25524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"/>
                <p:cNvSpPr/>
                <p:nvPr/>
              </p:nvSpPr>
              <p:spPr>
                <a:xfrm>
                  <a:off x="5790960" y="3442680"/>
                  <a:ext cx="88200" cy="331920"/>
                </a:xfrm>
                <a:prstGeom prst="rect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"/>
                <p:cNvSpPr/>
                <p:nvPr/>
              </p:nvSpPr>
              <p:spPr>
                <a:xfrm flipV="1">
                  <a:off x="3879000" y="3054960"/>
                  <a:ext cx="0" cy="1472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"/>
                <p:cNvSpPr/>
                <p:nvPr/>
              </p:nvSpPr>
              <p:spPr>
                <a:xfrm>
                  <a:off x="3866400" y="3055320"/>
                  <a:ext cx="2844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"/>
                <p:cNvSpPr/>
                <p:nvPr/>
              </p:nvSpPr>
              <p:spPr>
                <a:xfrm flipV="1">
                  <a:off x="4095000" y="3402000"/>
                  <a:ext cx="0" cy="295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"/>
                <p:cNvSpPr/>
                <p:nvPr/>
              </p:nvSpPr>
              <p:spPr>
                <a:xfrm>
                  <a:off x="4082400" y="3402000"/>
                  <a:ext cx="2808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"/>
                <p:cNvSpPr/>
                <p:nvPr/>
              </p:nvSpPr>
              <p:spPr>
                <a:xfrm flipV="1">
                  <a:off x="4311000" y="3319920"/>
                  <a:ext cx="0" cy="500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240" bIns="3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"/>
                <p:cNvSpPr/>
                <p:nvPr/>
              </p:nvSpPr>
              <p:spPr>
                <a:xfrm>
                  <a:off x="4299840" y="3320280"/>
                  <a:ext cx="2808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"/>
                <p:cNvSpPr/>
                <p:nvPr/>
              </p:nvSpPr>
              <p:spPr>
                <a:xfrm flipV="1">
                  <a:off x="4531320" y="3274560"/>
                  <a:ext cx="0" cy="24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"/>
                <p:cNvSpPr/>
                <p:nvPr/>
              </p:nvSpPr>
              <p:spPr>
                <a:xfrm>
                  <a:off x="4520160" y="3274920"/>
                  <a:ext cx="2664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"/>
                <p:cNvSpPr/>
                <p:nvPr/>
              </p:nvSpPr>
              <p:spPr>
                <a:xfrm flipV="1">
                  <a:off x="4749120" y="3365640"/>
                  <a:ext cx="0" cy="7200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0" bIns="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"/>
                <p:cNvSpPr/>
                <p:nvPr/>
              </p:nvSpPr>
              <p:spPr>
                <a:xfrm>
                  <a:off x="4736520" y="3365640"/>
                  <a:ext cx="2808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"/>
                <p:cNvSpPr/>
                <p:nvPr/>
              </p:nvSpPr>
              <p:spPr>
                <a:xfrm flipV="1">
                  <a:off x="4964760" y="3397320"/>
                  <a:ext cx="0" cy="1468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"/>
                <p:cNvSpPr/>
                <p:nvPr/>
              </p:nvSpPr>
              <p:spPr>
                <a:xfrm>
                  <a:off x="4952520" y="3397320"/>
                  <a:ext cx="2808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"/>
                <p:cNvSpPr/>
                <p:nvPr/>
              </p:nvSpPr>
              <p:spPr>
                <a:xfrm flipV="1">
                  <a:off x="5180760" y="3182040"/>
                  <a:ext cx="0" cy="4500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"/>
                <p:cNvSpPr/>
                <p:nvPr/>
              </p:nvSpPr>
              <p:spPr>
                <a:xfrm>
                  <a:off x="5169600" y="3182400"/>
                  <a:ext cx="2844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"/>
                <p:cNvSpPr/>
                <p:nvPr/>
              </p:nvSpPr>
              <p:spPr>
                <a:xfrm flipV="1">
                  <a:off x="5398560" y="2712240"/>
                  <a:ext cx="0" cy="266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"/>
                <p:cNvSpPr/>
                <p:nvPr/>
              </p:nvSpPr>
              <p:spPr>
                <a:xfrm>
                  <a:off x="5385600" y="2712240"/>
                  <a:ext cx="2844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"/>
                <p:cNvSpPr/>
                <p:nvPr/>
              </p:nvSpPr>
              <p:spPr>
                <a:xfrm flipV="1">
                  <a:off x="5618880" y="3487680"/>
                  <a:ext cx="0" cy="31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480" bIns="-15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"/>
                <p:cNvSpPr/>
                <p:nvPr/>
              </p:nvSpPr>
              <p:spPr>
                <a:xfrm>
                  <a:off x="5606280" y="3488040"/>
                  <a:ext cx="2808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"/>
                <p:cNvSpPr/>
                <p:nvPr/>
              </p:nvSpPr>
              <p:spPr>
                <a:xfrm flipV="1">
                  <a:off x="5834880" y="3410640"/>
                  <a:ext cx="0" cy="31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480" bIns="-15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"/>
                <p:cNvSpPr/>
                <p:nvPr/>
              </p:nvSpPr>
              <p:spPr>
                <a:xfrm>
                  <a:off x="5822280" y="3411000"/>
                  <a:ext cx="2808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"/>
                <p:cNvSpPr/>
                <p:nvPr/>
              </p:nvSpPr>
              <p:spPr>
                <a:xfrm>
                  <a:off x="3770280" y="3774960"/>
                  <a:ext cx="217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"/>
                <p:cNvSpPr/>
                <p:nvPr/>
              </p:nvSpPr>
              <p:spPr>
                <a:xfrm flipV="1">
                  <a:off x="377028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"/>
                <p:cNvSpPr/>
                <p:nvPr/>
              </p:nvSpPr>
              <p:spPr>
                <a:xfrm flipV="1">
                  <a:off x="398628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"/>
                <p:cNvSpPr/>
                <p:nvPr/>
              </p:nvSpPr>
              <p:spPr>
                <a:xfrm flipV="1">
                  <a:off x="420372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"/>
                <p:cNvSpPr/>
                <p:nvPr/>
              </p:nvSpPr>
              <p:spPr>
                <a:xfrm flipV="1">
                  <a:off x="442404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"/>
                <p:cNvSpPr/>
                <p:nvPr/>
              </p:nvSpPr>
              <p:spPr>
                <a:xfrm flipV="1">
                  <a:off x="464040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"/>
                <p:cNvSpPr/>
                <p:nvPr/>
              </p:nvSpPr>
              <p:spPr>
                <a:xfrm flipV="1">
                  <a:off x="485640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"/>
                <p:cNvSpPr/>
                <p:nvPr/>
              </p:nvSpPr>
              <p:spPr>
                <a:xfrm flipV="1">
                  <a:off x="507348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"/>
                <p:cNvSpPr/>
                <p:nvPr/>
              </p:nvSpPr>
              <p:spPr>
                <a:xfrm flipV="1">
                  <a:off x="528948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"/>
                <p:cNvSpPr/>
                <p:nvPr/>
              </p:nvSpPr>
              <p:spPr>
                <a:xfrm flipV="1">
                  <a:off x="551016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"/>
                <p:cNvSpPr/>
                <p:nvPr/>
              </p:nvSpPr>
              <p:spPr>
                <a:xfrm flipV="1">
                  <a:off x="572616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"/>
                <p:cNvSpPr/>
                <p:nvPr/>
              </p:nvSpPr>
              <p:spPr>
                <a:xfrm flipV="1">
                  <a:off x="5943600" y="3747960"/>
                  <a:ext cx="0" cy="26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160" bIns="-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"/>
                <p:cNvSpPr/>
                <p:nvPr/>
              </p:nvSpPr>
              <p:spPr>
                <a:xfrm>
                  <a:off x="3770280" y="3492720"/>
                  <a:ext cx="187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"/>
                <p:cNvSpPr/>
                <p:nvPr/>
              </p:nvSpPr>
              <p:spPr>
                <a:xfrm>
                  <a:off x="3770280" y="3218400"/>
                  <a:ext cx="187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"/>
                <p:cNvSpPr/>
                <p:nvPr/>
              </p:nvSpPr>
              <p:spPr>
                <a:xfrm>
                  <a:off x="3770280" y="2940840"/>
                  <a:ext cx="187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23" name=""/>
              <p:cNvSpPr/>
              <p:nvPr/>
            </p:nvSpPr>
            <p:spPr>
              <a:xfrm>
                <a:off x="3713400" y="2629080"/>
                <a:ext cx="1447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OsWRKY1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 express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24" name=""/>
          <p:cNvSpPr/>
          <p:nvPr/>
        </p:nvSpPr>
        <p:spPr>
          <a:xfrm>
            <a:off x="1582560" y="16383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2963520" y="1295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154320" y="1305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1382400" y="28321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1582560" y="33274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1973160" y="3247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2172960" y="3451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373120" y="33908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2563560" y="34196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773080" y="3460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2963520" y="3527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154320" y="34988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3963960" y="1552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4182840" y="15811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4402080" y="14860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4620960" y="15238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4840200" y="14479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5487840" y="14572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5716440" y="15145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973320" y="325764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4182840" y="31719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4620960" y="32194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840200" y="3238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5268600" y="25621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5487840" y="334332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5706720" y="32670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2563560" y="155268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微软用户</cp:lastModifiedBy>
  <dcterms:modified xsi:type="dcterms:W3CDTF">2009-05-21T06:49:48Z</dcterms:modified>
  <cp:revision>2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